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7" r:id="rId4"/>
    <p:sldId id="264" r:id="rId5"/>
    <p:sldId id="263" r:id="rId6"/>
    <p:sldId id="258" r:id="rId7"/>
    <p:sldId id="259" r:id="rId8"/>
    <p:sldId id="261" r:id="rId9"/>
    <p:sldId id="262" r:id="rId10"/>
    <p:sldId id="265" r:id="rId11"/>
    <p:sldId id="266" r:id="rId12"/>
    <p:sldId id="267" r:id="rId13"/>
    <p:sldId id="268" r:id="rId14"/>
    <p:sldId id="269" r:id="rId15"/>
    <p:sldId id="270" r:id="rId16"/>
    <p:sldId id="271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448" autoAdjust="0"/>
    <p:restoredTop sz="94660"/>
  </p:normalViewPr>
  <p:slideViewPr>
    <p:cSldViewPr snapToGrid="0">
      <p:cViewPr varScale="1">
        <p:scale>
          <a:sx n="64" d="100"/>
          <a:sy n="64" d="100"/>
        </p:scale>
        <p:origin x="78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33927D-5C18-469D-92B1-97B2E8F75F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401ED1-60CA-448B-8C7C-AE0196E89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028F8E-7ADF-4EA0-8248-21E22B4E9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86F317-5C0B-41AD-A4D0-7566F6E90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41F726-DE75-4483-96F5-E00EFE99B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69464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69CAA4-AF2D-4A6A-A5FF-80C05DE7B0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A98E2E-D72F-4E48-B079-4B40D08621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0F082E-4AA9-4D7F-9164-F58EFDD9B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3B1C7E-E479-461D-94FA-D45F274D2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5B8182-2498-4BAD-9940-41BBF5492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02344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509B38-EC3C-49A7-9376-3A73DCD4E9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1A96B3-A156-4252-98E2-F3E11C3FCD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CC6E92-6A0C-41B5-B550-B54AE5573D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000142-EDE3-47BA-882E-F814029C7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1DBC3C-0F39-4577-92A0-CEDB4A93E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61927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C1B3ED-F18C-4624-855E-D68D9C50FB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922707-1F00-4B68-8DE2-8D46414E6F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6F8B1-CCFE-467F-8BFA-B8776D4D8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F3DB23-C464-45F4-9B4D-8E33004ED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11B5ED-815A-4BE9-AE01-197F77E37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32815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A1C7B8-139A-406D-A4F4-826D21E38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AE3A3D-622F-4DF1-AD74-0832830FC7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0E315B-63F2-4017-88E5-E10C93B05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265F13-73AB-4549-8A56-B562916E1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8124FD-B45C-45D9-88BE-3E327F689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11965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721047-66EB-4B99-99A4-09FF8CE604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1CF234-9CC1-4A40-AED1-B4CB803A09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E4D333-F684-458A-A879-5259D5EA44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BD35A3-4E4D-4A82-BBE9-509CBABFC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1B1D16-0AE8-4833-9CAD-050828E300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0D0D80-72E2-4CD0-9D77-A61FAFAF5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56753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E6304C-1397-4F40-ABFF-342D7F4486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96B9F1-0F78-4719-80B4-DD9E8C6AC0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D01A60-E8D5-4469-B56A-8E12320C39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9AFA61-5AD5-4528-A8FF-3FF969B968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BF25C9-7DD4-4BD5-B02F-CF5463CD9B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CBEBFD-C5AC-4A7B-AD7C-C8DCDA60B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D621BF-7E42-43A5-A4B1-53B2FDAFF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2B73C2-19BB-4A47-A7BE-7E6E3BB9D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4173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8533FA-75D0-44BC-86D3-AFCF46259D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09156B-2A85-4D22-B62A-0553C3C76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C20C7C-17F2-40E1-8D70-5EA5C20CC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CCF134A-CA30-40F3-A63D-4697DCB5B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65232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BDF6F3D-C7D8-4A3E-8E78-37BC3BACB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EA5CA6-C5E4-4FD8-BA49-F73837B1D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7536A0-33C1-4C9C-8757-941D9B36C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78514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0739CA-E728-4DE4-9278-E8CE44859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8F8BF2-F743-4DB6-A3D8-5E058BCE77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9FCEF4-E9CA-49BD-A15A-C5C462FF78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A63DA4-1D0C-4AC6-AA5D-3ED963FB9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06B974-F35C-4634-9EBA-6AFA8CD6C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8A3DAD-ABA2-452B-A3CF-54060BF5C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36106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4B07B1-E1F1-4D69-B0C5-A4DAA62F5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5CFEE7-0C9E-4BC3-A76E-686036A43E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3516F8-C5BA-420B-ABCE-2B35D29E17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4CD6C3-178B-4837-B713-94B17BE36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7ABE67-D7CB-4E99-84F5-70F88C6D2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D20B80-62BE-409F-8305-6C69191AF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2316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F8DF5F-A64E-4D1E-8AE4-91BCE1B99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2FBF29-26DE-4BCC-88CE-1186D5B996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F9268-8CD3-4BF1-84D6-44D26F01C3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47C55-8F1D-4417-9684-9FC99E3287E2}" type="datetimeFigureOut">
              <a:rPr lang="en-GB" smtClean="0"/>
              <a:t>23/07/2019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923888-7593-4D63-88C0-6EA87CE662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21D55B-745C-4E00-AA7E-3A96A361DC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94BE3-BCAE-4B99-9685-30BC6D1C5C4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39864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hyperlink" Target="https://play.google.com/store/apps/details?id=com.spd.eliawellness" TargetMode="External"/><Relationship Id="rId2" Type="http://schemas.openxmlformats.org/officeDocument/2006/relationships/hyperlink" Target="https://apps.apple.com/us/app/mywellness/id1434379771?ls=1" TargetMode="Externa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s://eliawellness.com/" TargetMode="Externa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AFD93A51-1778-4462-8E7E-4B007193D16D}"/>
              </a:ext>
            </a:extLst>
          </p:cNvPr>
          <p:cNvSpPr>
            <a:spLocks noGrp="1"/>
          </p:cNvSpPr>
          <p:nvPr>
            <p:ph type="ctrTitle" idx="4294967295"/>
          </p:nvPr>
        </p:nvSpPr>
        <p:spPr>
          <a:xfrm>
            <a:off x="306049" y="149903"/>
            <a:ext cx="11579902" cy="4661940"/>
          </a:xfrm>
        </p:spPr>
        <p:txBody>
          <a:bodyPr>
            <a:normAutofit/>
          </a:bodyPr>
          <a:lstStyle/>
          <a:p>
            <a:pPr algn="ctr"/>
            <a:r>
              <a:rPr lang="en-AU" sz="2800" dirty="0"/>
              <a:t>These images portray features of the website e-learning management system and mobile app relating to the following article:</a:t>
            </a:r>
            <a:br>
              <a:rPr lang="en-AU" sz="2800" dirty="0"/>
            </a:br>
            <a:br>
              <a:rPr lang="en-AU" dirty="0"/>
            </a:br>
            <a:r>
              <a:rPr lang="en-AU" dirty="0"/>
              <a:t>A Web- and Mobile-app-based Mental Health Promotion Intervention Comparing Email, SMS and Videoconferencing Support for a Healthy Cohort: A Randomized Comparative Study</a:t>
            </a:r>
            <a:endParaRPr lang="en-GB" dirty="0"/>
          </a:p>
        </p:txBody>
      </p:sp>
      <p:sp>
        <p:nvSpPr>
          <p:cNvPr id="5" name="Subtitle 4">
            <a:extLst>
              <a:ext uri="{FF2B5EF4-FFF2-40B4-BE49-F238E27FC236}">
                <a16:creationId xmlns:a16="http://schemas.microsoft.com/office/drawing/2014/main" id="{4AE23CFF-0CC2-4C9B-BED4-3F2563A958CE}"/>
              </a:ext>
            </a:extLst>
          </p:cNvPr>
          <p:cNvSpPr>
            <a:spLocks noGrp="1"/>
          </p:cNvSpPr>
          <p:nvPr>
            <p:ph type="subTitle" idx="4294967295"/>
          </p:nvPr>
        </p:nvSpPr>
        <p:spPr>
          <a:xfrm>
            <a:off x="1524000" y="4591389"/>
            <a:ext cx="9144000" cy="1655762"/>
          </a:xfrm>
        </p:spPr>
        <p:txBody>
          <a:bodyPr/>
          <a:lstStyle/>
          <a:p>
            <a:endParaRPr lang="en-AU" dirty="0"/>
          </a:p>
          <a:p>
            <a:pPr marL="0" indent="0" algn="ctr">
              <a:buNone/>
            </a:pPr>
            <a:r>
              <a:rPr lang="en-AU" sz="1800" dirty="0"/>
              <a:t>Authors: Renfrew M, Morton D, Morton J, Hinze J, Beamish P, Przybylko G, Craig B.</a:t>
            </a:r>
          </a:p>
        </p:txBody>
      </p:sp>
    </p:spTree>
    <p:extLst>
      <p:ext uri="{BB962C8B-B14F-4D97-AF65-F5344CB8AC3E}">
        <p14:creationId xmlns:p14="http://schemas.microsoft.com/office/powerpoint/2010/main" val="3542571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AFD93A51-1778-4462-8E7E-4B007193D16D}"/>
              </a:ext>
            </a:extLst>
          </p:cNvPr>
          <p:cNvSpPr>
            <a:spLocks noGrp="1"/>
          </p:cNvSpPr>
          <p:nvPr>
            <p:ph type="ctrTitle" idx="4294967295"/>
          </p:nvPr>
        </p:nvSpPr>
        <p:spPr>
          <a:xfrm>
            <a:off x="1588958" y="547141"/>
            <a:ext cx="9144000" cy="4452079"/>
          </a:xfrm>
        </p:spPr>
        <p:txBody>
          <a:bodyPr>
            <a:normAutofit fontScale="90000"/>
          </a:bodyPr>
          <a:lstStyle/>
          <a:p>
            <a:pPr algn="ctr"/>
            <a:r>
              <a:rPr lang="en-AU" dirty="0"/>
              <a:t>Section 2:  </a:t>
            </a:r>
            <a:br>
              <a:rPr lang="en-AU" dirty="0"/>
            </a:br>
            <a:br>
              <a:rPr lang="en-AU" dirty="0"/>
            </a:br>
            <a:r>
              <a:rPr lang="en-AU" dirty="0"/>
              <a:t>The App</a:t>
            </a:r>
            <a:br>
              <a:rPr lang="en-AU" dirty="0"/>
            </a:br>
            <a:br>
              <a:rPr lang="en-AU" dirty="0"/>
            </a:br>
            <a:r>
              <a:rPr lang="en-AU" dirty="0"/>
              <a:t>The following images are from the mobile app called “</a:t>
            </a:r>
            <a:r>
              <a:rPr lang="en-AU" dirty="0" err="1"/>
              <a:t>mywellness</a:t>
            </a:r>
            <a:r>
              <a:rPr lang="en-AU" dirty="0"/>
              <a:t>” – available on the “App Store” and “Google Play”</a:t>
            </a:r>
            <a:endParaRPr lang="en-GB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6ABB03B-AC1A-487C-AEC8-D939E3B2A54B}"/>
              </a:ext>
            </a:extLst>
          </p:cNvPr>
          <p:cNvSpPr/>
          <p:nvPr/>
        </p:nvSpPr>
        <p:spPr>
          <a:xfrm>
            <a:off x="2768184" y="5301893"/>
            <a:ext cx="678554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>
                <a:hlinkClick r:id="rId2"/>
              </a:rPr>
              <a:t>https://apps.apple.com/us/app/mywellness/id1434379771?ls=1</a:t>
            </a:r>
            <a:endParaRPr lang="en-GB" dirty="0"/>
          </a:p>
          <a:p>
            <a:endParaRPr lang="en-GB" dirty="0"/>
          </a:p>
          <a:p>
            <a:r>
              <a:rPr lang="en-GB" dirty="0">
                <a:hlinkClick r:id="rId3"/>
              </a:rPr>
              <a:t>https://play.google.com/store/apps/details?id=com.spd.eliawellness</a:t>
            </a:r>
            <a:r>
              <a:rPr lang="en-GB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12179516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1463817" y="6129507"/>
            <a:ext cx="88741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Questionnaire: </a:t>
            </a:r>
            <a:r>
              <a:rPr lang="en-AU" dirty="0"/>
              <a:t>Once a participant tapped the answer to the question on the screen, the screen automatically moved to the next questio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FFD73B0-86A5-4CF5-8227-D94B4EAB60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3469" y="351666"/>
            <a:ext cx="3132150" cy="555956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3D9C9CD-4FDC-4A3A-8251-30386D8641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3597" y="351666"/>
            <a:ext cx="3132150" cy="55595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68769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1553758" y="6137002"/>
            <a:ext cx="88741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Comparison of Questionnaire Results – Pre &amp; Post:  </a:t>
            </a:r>
            <a:r>
              <a:rPr lang="en-AU" dirty="0"/>
              <a:t>Participants could compare their results before and after the intervent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1575ED6-F83A-4B31-9C50-12A564D15C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1500" y="162515"/>
            <a:ext cx="3310884" cy="5886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396554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1531273" y="5762283"/>
            <a:ext cx="887417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Video content on the mobile app: </a:t>
            </a:r>
            <a:r>
              <a:rPr lang="en-AU" dirty="0"/>
              <a:t>Participants watched the video content and could download a workbook and a chapter of the accompanying text-book book “Live More Happy” (Morton, 2018) from the Lessons page on the app (or the website)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366F78D-81A6-448A-AEAB-5EF531D2B6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9731" y="290916"/>
            <a:ext cx="2778646" cy="493209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460252D-F483-4BD8-85C2-DECE5A30BF1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9741" y="290916"/>
            <a:ext cx="2883804" cy="51187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362471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1553758" y="6137002"/>
            <a:ext cx="88741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Challenges on the App: </a:t>
            </a:r>
            <a:r>
              <a:rPr lang="en-AU" dirty="0"/>
              <a:t>Participants could click on the icon and then record challenge activity while ‘on the go’.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B9AF882-EF04-4960-AA0F-EF0DE4B59C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009" y="333222"/>
            <a:ext cx="3166152" cy="56199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ED783FD-0886-4537-99D9-2F380B01DD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2923" y="326956"/>
            <a:ext cx="3166153" cy="562618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78167EC-4A88-4EAB-AA81-3328E83032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08014" y="326956"/>
            <a:ext cx="3138977" cy="56261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861726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525983" y="6031806"/>
            <a:ext cx="111508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 err="1"/>
              <a:t>Leaderboard</a:t>
            </a:r>
            <a:r>
              <a:rPr lang="en-AU" b="1" dirty="0"/>
              <a:t> and extra articles: </a:t>
            </a:r>
            <a:r>
              <a:rPr lang="en-AU" dirty="0"/>
              <a:t>Names and photos have been removed for privacy.  Participants could compare their progress with others on the </a:t>
            </a:r>
            <a:r>
              <a:rPr lang="en-AU" dirty="0" err="1"/>
              <a:t>leaderboard</a:t>
            </a:r>
            <a:r>
              <a:rPr lang="en-AU" dirty="0"/>
              <a:t> and read articles of interest related to the topics of the program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FE3BAEF-DE58-449A-8B8F-087A6DAA50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0414" y="242629"/>
            <a:ext cx="3156273" cy="561115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D459DD6-B509-4113-9885-4B408275AA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69599" y="246532"/>
            <a:ext cx="3228378" cy="56072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091624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406061" y="1160002"/>
            <a:ext cx="1115082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References</a:t>
            </a:r>
          </a:p>
          <a:p>
            <a:pPr algn="ctr"/>
            <a:endParaRPr lang="en-AU" b="1" dirty="0"/>
          </a:p>
          <a:p>
            <a:r>
              <a:rPr lang="en-GB" dirty="0"/>
              <a:t>Morton D, Live more happy : scientifically proven ways to lift your mood and your life. Warburton, Vic.: Signs Publishing Company; 2018; ISBN:9781925044720.</a:t>
            </a:r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078038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AFD93A51-1778-4462-8E7E-4B007193D16D}"/>
              </a:ext>
            </a:extLst>
          </p:cNvPr>
          <p:cNvSpPr>
            <a:spLocks noGrp="1"/>
          </p:cNvSpPr>
          <p:nvPr>
            <p:ph type="ctrTitle" idx="4294967295"/>
          </p:nvPr>
        </p:nvSpPr>
        <p:spPr>
          <a:xfrm>
            <a:off x="83616" y="99724"/>
            <a:ext cx="11782425" cy="6450978"/>
          </a:xfrm>
        </p:spPr>
        <p:txBody>
          <a:bodyPr>
            <a:noAutofit/>
          </a:bodyPr>
          <a:lstStyle/>
          <a:p>
            <a:pPr algn="ctr"/>
            <a:r>
              <a:rPr lang="en-AU" dirty="0"/>
              <a:t>Section 1: </a:t>
            </a:r>
            <a:br>
              <a:rPr lang="en-AU" dirty="0"/>
            </a:br>
            <a:br>
              <a:rPr lang="en-AU" dirty="0"/>
            </a:br>
            <a:r>
              <a:rPr lang="en-AU" dirty="0"/>
              <a:t>The Website </a:t>
            </a:r>
            <a:br>
              <a:rPr lang="en-AU" dirty="0"/>
            </a:br>
            <a:br>
              <a:rPr lang="en-AU" dirty="0"/>
            </a:br>
            <a:r>
              <a:rPr lang="en-AU" dirty="0"/>
              <a:t>Images of the website </a:t>
            </a:r>
            <a:br>
              <a:rPr lang="en-AU" dirty="0"/>
            </a:br>
            <a:r>
              <a:rPr lang="en-AU" dirty="0"/>
              <a:t>(e-learning management system)</a:t>
            </a:r>
            <a:br>
              <a:rPr lang="en-AU" dirty="0"/>
            </a:br>
            <a:r>
              <a:rPr lang="en-AU" dirty="0"/>
              <a:t> </a:t>
            </a:r>
            <a:br>
              <a:rPr lang="en-AU" dirty="0"/>
            </a:br>
            <a:r>
              <a:rPr lang="en-AU" dirty="0">
                <a:hlinkClick r:id="rId2"/>
              </a:rPr>
              <a:t>https://eliawellness.com/</a:t>
            </a:r>
            <a:r>
              <a:rPr lang="en-AU" dirty="0"/>
              <a:t> </a:t>
            </a:r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F6C27C6-DCCD-4352-A6E8-65F95D34D090}"/>
              </a:ext>
            </a:extLst>
          </p:cNvPr>
          <p:cNvSpPr txBox="1"/>
          <p:nvPr/>
        </p:nvSpPr>
        <p:spPr>
          <a:xfrm>
            <a:off x="1229193" y="805131"/>
            <a:ext cx="9491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 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886473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1272913" y="5621311"/>
            <a:ext cx="94812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To Do List</a:t>
            </a:r>
            <a:r>
              <a:rPr lang="en-AU" dirty="0"/>
              <a:t>: An online “To Do” list (available on each personal dashboard) provided easily accessible links to complete the various components.  Note: the “wellness snapshot” refers to the questionnaire administered at baseline and after completion of the program.</a:t>
            </a:r>
            <a:endParaRPr lang="en-GB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F58D36F-36FD-4A30-9C5D-77CC3A3179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7896" y="552521"/>
            <a:ext cx="5279461" cy="48289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52172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1272913" y="5621311"/>
            <a:ext cx="94812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Overview of Wellness Snapshot Results</a:t>
            </a:r>
            <a:r>
              <a:rPr lang="en-AU" dirty="0"/>
              <a:t>:  The “Wellness Snapshot” (i.e. questionnaire) provided a visual overview of where an individual was located on a continuum in seven different dimensions.  A pie-chart view and percentage score out of 100 was also available. </a:t>
            </a:r>
            <a:endParaRPr lang="en-GB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80468E3-ED2E-408E-A2F8-A9086A8ECB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8790" y="697043"/>
            <a:ext cx="8104507" cy="45516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94248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F522D53-D024-462E-BFED-4B53E88D5F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5280" y="142407"/>
            <a:ext cx="9896547" cy="514353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1272913" y="5621311"/>
            <a:ext cx="94812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Sample View of Lesson 6 Content</a:t>
            </a:r>
            <a:r>
              <a:rPr lang="en-AU" dirty="0"/>
              <a:t>: Each lesson was divided into 3-4 short video presentations. Each new video segment was unlocked, on completion of the previous video.  Segments were ticked off automatically as they were viewed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840166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4E69C6F-47F6-414F-9D4B-8892807C5D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9858" y="183849"/>
            <a:ext cx="9494930" cy="487783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882790" y="5219308"/>
            <a:ext cx="992906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View of challenge icons for lessons 1-6</a:t>
            </a:r>
            <a:r>
              <a:rPr lang="en-AU" dirty="0"/>
              <a:t>: After each lesson, participants are provided with daily and weekly challenges.  For example, for Lesson 6, participants were challenged to eat 8 fists full of fibre daily, and were asked to make 1 high-fibre plant based meal for the weekly challenge - “</a:t>
            </a:r>
            <a:r>
              <a:rPr lang="en-AU" dirty="0" err="1"/>
              <a:t>Masterchef</a:t>
            </a:r>
            <a:r>
              <a:rPr lang="en-AU" dirty="0"/>
              <a:t> Me”. 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6CD16122-6B1F-47FB-A1DC-BDAD4EAB16A6}"/>
              </a:ext>
            </a:extLst>
          </p:cNvPr>
          <p:cNvSpPr/>
          <p:nvPr/>
        </p:nvSpPr>
        <p:spPr>
          <a:xfrm>
            <a:off x="3337234" y="3621318"/>
            <a:ext cx="2106118" cy="906905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6B6DECB2-860F-44A2-853B-87241CB12B66}"/>
              </a:ext>
            </a:extLst>
          </p:cNvPr>
          <p:cNvSpPr/>
          <p:nvPr/>
        </p:nvSpPr>
        <p:spPr>
          <a:xfrm>
            <a:off x="8147644" y="3738179"/>
            <a:ext cx="2106118" cy="906905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63348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77449" y="5725127"/>
            <a:ext cx="120371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View of Lesson 6 Challenge Log Pages: </a:t>
            </a:r>
            <a:r>
              <a:rPr lang="en-AU" dirty="0"/>
              <a:t>When participants clicked on the challenge icon (previous screen) it opened up a screen to log daily challenges (possibility of 10 points scored daily) and weekly challenges (30 points scored per week).  Name and photo ID has been obscured for privacy reason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64F9527-FF02-4DE9-8EA8-A757AB5C87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3659" y="307298"/>
            <a:ext cx="4170162" cy="527958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B222280-001D-4EF2-B182-5A1920039C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307298"/>
            <a:ext cx="4254952" cy="52795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20506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77449" y="5710136"/>
            <a:ext cx="120371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dirty="0"/>
              <a:t>View of </a:t>
            </a:r>
            <a:r>
              <a:rPr lang="en-AU" b="1" dirty="0" err="1"/>
              <a:t>Leaderboard</a:t>
            </a:r>
            <a:r>
              <a:rPr lang="en-AU" b="1" dirty="0"/>
              <a:t> </a:t>
            </a:r>
            <a:r>
              <a:rPr lang="en-AU" dirty="0"/>
              <a:t>Names and photos have been blocked to protect privacy. Participants could compare their scores with others and earn badges for engagement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0A37E99-7E56-4026-B4BE-FE4E71A312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9848" y="240803"/>
            <a:ext cx="8992302" cy="53908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49325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1074A6-56D7-4FD4-869C-D32981A913B0}"/>
              </a:ext>
            </a:extLst>
          </p:cNvPr>
          <p:cNvSpPr txBox="1"/>
          <p:nvPr/>
        </p:nvSpPr>
        <p:spPr>
          <a:xfrm>
            <a:off x="1658911" y="5792582"/>
            <a:ext cx="88741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Extra articles on various topics:  </a:t>
            </a:r>
            <a:r>
              <a:rPr lang="en-AU" dirty="0"/>
              <a:t>Participants could read extra information on topics covered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5A48A22-90E3-46F7-B68D-D11A012424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4547" y="410181"/>
            <a:ext cx="8763064" cy="50482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8882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563</Words>
  <Application>Microsoft Office PowerPoint</Application>
  <PresentationFormat>Widescreen</PresentationFormat>
  <Paragraphs>24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These images portray features of the website e-learning management system and mobile app relating to the following article:  A Web- and Mobile-app-based Mental Health Promotion Intervention Comparing Email, SMS and Videoconferencing Support for a Healthy Cohort: A Randomized Comparative Study</vt:lpstr>
      <vt:lpstr>Section 1:   The Website   Images of the website  (e-learning management system)   https://eliawellness.com/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ection 2:    The App  The following images are from the mobile app called “mywellness” – available on the “App Store” and “Google Play”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creenshots of the website and mobile app for the Live More Project Mental Wellbeing Intervention</dc:title>
  <dc:creator>Mel Renfrew</dc:creator>
  <cp:lastModifiedBy>Mel Renfrew</cp:lastModifiedBy>
  <cp:revision>15</cp:revision>
  <dcterms:created xsi:type="dcterms:W3CDTF">2019-07-18T03:56:35Z</dcterms:created>
  <dcterms:modified xsi:type="dcterms:W3CDTF">2019-07-23T05:11:05Z</dcterms:modified>
</cp:coreProperties>
</file>